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274F4-EEB7-29DC-92F5-98ABA22808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319017-BD88-21D6-0183-700F371A5D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C5CD33-564E-60E8-80CC-A1AF73410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F84B29-1B0F-5F17-8B75-DF0FB140B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5C943F-912B-7EE5-5566-D03548C34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01681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0B29D1-C428-CDE8-9C98-8C4832B9C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000EE2-01BD-DA80-12C9-F0E8F84C00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23FCC1-2C8B-0EA3-57EB-54DB796CF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6CFCBB-3F6A-B184-9851-154B55F5F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121CC3-B645-94EC-43A8-CDDF15E7E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52523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C5789B-C64B-8EEC-55D3-470BD01526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3B450F-E75C-EC63-4ED2-90DE35DF60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C176D9-53B7-7FB5-995F-9EEB31999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C2117B-7DAF-3C39-04BC-559A88913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B419CB-39C6-46FD-BD63-F6B18DCE0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62625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44C01-20DF-4DE1-601E-30EE5D1998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95B3FB-333D-029B-D7BF-ADD8E7D974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CCB31E-0122-A5D5-25DA-905E43002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09B977-0759-1D05-3904-F39651B40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EA724-B3F4-BA18-D5DD-AD588ABB9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95455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4AB8D4-154C-9D2D-472D-4442F685F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354676-CC2A-EAA5-34C5-4D4D9D57EB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E01594-AC47-CED0-F254-B2C4FB9F6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7603B-8448-81B8-F444-54B34CC94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F981EA-524F-2C64-11B6-FF193C301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18730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CCC59-BD56-36E9-0291-EB8B757D3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185758-EFFB-3D7E-7127-28E289F63E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7B4858-4793-26FE-9673-4605C56531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9CB6EC-89A7-8435-D240-C2361EC58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034D21-AD59-9563-C606-EE9C3593B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F19699-7183-DD81-A02A-9ACD068F5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88147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DD624-AF13-6714-6717-6DBC3B61F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99B383-D06E-BDB2-DE41-82528DC89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05B538-DEF7-315F-5E26-1ACF87AEC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F2FB8F-4928-883B-B0AF-C2895AF6A4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9DE2FA-4B9F-109F-5FB4-05F6236B6F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F49E86-3D40-30BE-B737-65693F914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145D5A-D125-B3FA-8AF2-F8DC4DBBE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62EC9F0-30BF-CB44-CE48-EA2786512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47618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D15F6-6052-6421-AB1C-EA0F7FEED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D9E977-5CC1-DB0A-9055-8E3E6B1BC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417E97-5780-AA7E-9341-2AABE219B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5C1BD2-99E9-503B-7A14-4FBFFC2BE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75056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E673A5-0834-A683-823A-44B5094D3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0BFD20-446A-6BC9-527F-54D322059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44BDCE-88A6-9AF6-CA26-72DC5FD8F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2653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3893D4-CAED-A294-5A24-FA98BDA88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6A4D12-F223-2B87-8860-6C99305D78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506E72-C5CB-8509-CD3B-980580CA96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797197-8BB6-FE94-DD74-0C38A15F1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7AD4B9-0CCB-2566-CE32-29F4BD2A2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F786F0-EB46-C798-6A33-16AD2AFA9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20307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69EC6-7F78-1C4E-173C-4CF2871B4B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D98690-0BD8-43F5-5EDE-36785FD248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92520C-F43D-2686-6EBB-F621DD85C9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C0C5E6-B683-00E1-E502-C08F748E8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BB421E-A29B-149D-79BD-7373F2761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4BC2F4-4CB9-4B16-BE69-E2888193A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19351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3374D3-2F70-AD10-524E-168553684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BFAEEE-950A-C4A6-AAE1-42F6C9E762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4D7BDB-7822-10AA-B4BC-FD3CA68DFC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05263C-1F8E-426A-AAF2-6F5A4AB4CABA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CDEBCD-3CE1-A0EB-D54E-FE1CD7C441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097EE2-B08D-6EC8-A846-1BFA87FC5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4C1C7-94AA-4C6D-AC71-DF381869C40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68601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511AF3E-C25B-9E32-BE1C-D3E0C8118C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8840" y="0"/>
            <a:ext cx="10821798" cy="60872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06570C3-D186-69BF-1D28-9D465EA146C3}"/>
              </a:ext>
            </a:extLst>
          </p:cNvPr>
          <p:cNvSpPr txBox="1"/>
          <p:nvPr/>
        </p:nvSpPr>
        <p:spPr>
          <a:xfrm>
            <a:off x="343949" y="6233020"/>
            <a:ext cx="116187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S2</a:t>
            </a:r>
            <a:r>
              <a:rPr lang="en-ZA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Scatter plot produced by plotting </a:t>
            </a:r>
            <a:r>
              <a:rPr lang="en-ZA" sz="1200" i="1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uchnera</a:t>
            </a:r>
            <a:r>
              <a:rPr lang="en-ZA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protein coding gene %GC content over </a:t>
            </a:r>
            <a:r>
              <a:rPr lang="en-ZA" sz="1200" i="1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uchnera</a:t>
            </a:r>
            <a:r>
              <a:rPr lang="en-ZA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protein identity towards their </a:t>
            </a:r>
            <a:r>
              <a:rPr lang="en-ZA" sz="1200" i="1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cherichia coli</a:t>
            </a:r>
            <a:r>
              <a:rPr lang="en-ZA" sz="1200" kern="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protein homologs. </a:t>
            </a:r>
            <a:endParaRPr lang="en-ZA" sz="1200" dirty="0"/>
          </a:p>
        </p:txBody>
      </p:sp>
    </p:spTree>
    <p:extLst>
      <p:ext uri="{BB962C8B-B14F-4D97-AF65-F5344CB8AC3E}">
        <p14:creationId xmlns:p14="http://schemas.microsoft.com/office/powerpoint/2010/main" val="420863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Dr [nfvburger@sun.ac.za]</dc:creator>
  <cp:lastModifiedBy>Oberholster, A, Prof [ambo@sun.ac.za]</cp:lastModifiedBy>
  <cp:revision>4</cp:revision>
  <dcterms:created xsi:type="dcterms:W3CDTF">2023-09-27T11:22:10Z</dcterms:created>
  <dcterms:modified xsi:type="dcterms:W3CDTF">2024-01-17T12:32:00Z</dcterms:modified>
</cp:coreProperties>
</file>